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84" r:id="rId1"/>
  </p:sldMasterIdLst>
  <p:notesMasterIdLst>
    <p:notesMasterId r:id="rId3"/>
  </p:notesMasterIdLst>
  <p:sldIdLst>
    <p:sldId id="284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810" y="-72"/>
      </p:cViewPr>
      <p:guideLst>
        <p:guide orient="horz" pos="31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7965BD-FD03-4C8F-A197-EC50D7697508}" type="datetimeFigureOut">
              <a:rPr lang="en-US" smtClean="0"/>
              <a:t>8/25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BED53-BBA4-43C4-9D66-9DCD963724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7183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1" y="561343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7835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06026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1" y="39673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3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79537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36651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6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61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832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1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3082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25" y="2217387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25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94" y="2217387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94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25439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22914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81448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25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12" y="39443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25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89107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5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280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8/25/2014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89301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4599962"/>
              </p:ext>
            </p:extLst>
          </p:nvPr>
        </p:nvGraphicFramePr>
        <p:xfrm>
          <a:off x="723900" y="381000"/>
          <a:ext cx="5867400" cy="8769480"/>
        </p:xfrm>
        <a:graphic>
          <a:graphicData uri="http://schemas.openxmlformats.org/drawingml/2006/table">
            <a:tbl>
              <a:tblPr/>
              <a:tblGrid>
                <a:gridCol w="1219200"/>
                <a:gridCol w="1828800"/>
                <a:gridCol w="1828800"/>
                <a:gridCol w="990600"/>
              </a:tblGrid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NA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am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R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*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nce (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r-MIR168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a-MIR168a1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h-MIR168a1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h-MIR168a2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a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y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a-MIR168a1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a-MIR168a2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r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a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a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UAUCAAG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u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y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UCUUGU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h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UCUUGU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na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A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U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u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fl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m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c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c_WS0113_J15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c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t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1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co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vi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s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s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UGCCUUGCG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m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me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9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m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r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UGCUUGGUGCU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e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UGCCUUGCAUCAAUC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r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r-MIR168c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UGCCUUGCAUCAAUC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un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a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972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a_GMFL01-03-A13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a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a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A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CCAAG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i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A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CCAAG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vu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A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CCAAG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bi-MIR168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A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CCAAG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ma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A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CCAAG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ma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A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CCAAG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f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A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CCAAG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p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A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CCAAG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a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UGCCUUA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a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a-MIR168c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U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a-MIR168d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CCAAG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6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a-MIR168e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A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1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y-MIR168a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23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y-MIR168b</a:t>
                      </a:r>
                    </a:p>
                  </a:txBody>
                  <a:tcPr marL="5188" marR="5188" marT="5188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CGCUUGGUGCAGGUCGGGAC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UUGCAUCAACUGAAU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 marL="5188" marR="5188" marT="518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971800" y="16162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Figure S3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0" y="9220200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3.</a:t>
            </a:r>
            <a:r>
              <a:rPr lang="en-US" sz="1200" dirty="0" smtClean="0"/>
              <a:t>  </a:t>
            </a:r>
            <a:r>
              <a:rPr lang="en-US" sz="1200" dirty="0"/>
              <a:t>Length of loops  (distance between </a:t>
            </a:r>
            <a:r>
              <a:rPr lang="en-US" sz="1200" dirty="0" err="1"/>
              <a:t>miRNa</a:t>
            </a:r>
            <a:r>
              <a:rPr lang="en-US" sz="1200" dirty="0"/>
              <a:t> and </a:t>
            </a:r>
            <a:r>
              <a:rPr lang="en-US" sz="1200" dirty="0" err="1"/>
              <a:t>miRNA</a:t>
            </a:r>
            <a:r>
              <a:rPr lang="en-US" sz="1200" dirty="0"/>
              <a:t>*) among 58 miR168 precursors from diverse plants. Dicots, monocots and </a:t>
            </a:r>
            <a:r>
              <a:rPr lang="en-US" sz="1200" i="1" dirty="0" err="1"/>
              <a:t>Solanaceae</a:t>
            </a:r>
            <a:r>
              <a:rPr lang="en-US" sz="1200" dirty="0"/>
              <a:t> members have been separated to indicate clade-specific change in loop length.  Extremely long loop sin two members of tobacco have been marked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693077406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9</TotalTime>
  <Words>292</Words>
  <Application>Microsoft Office PowerPoint</Application>
  <PresentationFormat>A4 Paper (210x297 mm)</PresentationFormat>
  <Paragraphs>2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vaprasad</dc:creator>
  <cp:lastModifiedBy>Shivaprasad</cp:lastModifiedBy>
  <cp:revision>128</cp:revision>
  <dcterms:created xsi:type="dcterms:W3CDTF">2006-08-16T00:00:00Z</dcterms:created>
  <dcterms:modified xsi:type="dcterms:W3CDTF">2014-08-25T07:01:02Z</dcterms:modified>
</cp:coreProperties>
</file>